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33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2545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343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836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812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37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64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184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8837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6041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0227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3265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F2D62-1C11-4C06-BED0-B00622AED66F}" type="datetimeFigureOut">
              <a:rPr lang="en-GB" smtClean="0"/>
              <a:pPr/>
              <a:t>13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DBDCA3-B399-415D-8E8C-C314789FF75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739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779912" y="3717032"/>
            <a:ext cx="1447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Decreases</a:t>
            </a:r>
            <a:endParaRPr lang="en-GB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707904" y="1124744"/>
            <a:ext cx="1447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Increases</a:t>
            </a:r>
            <a:endParaRPr lang="en-GB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7092280" y="6021288"/>
            <a:ext cx="151909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 </a:t>
            </a:r>
            <a:r>
              <a:rPr lang="en-GB" sz="1600" b="1" dirty="0" smtClean="0"/>
              <a:t>Other-distorted</a:t>
            </a:r>
            <a:endParaRPr lang="en-GB" sz="16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716016" y="6093296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Other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83768" y="6021288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elf-distorted</a:t>
            </a:r>
            <a:endParaRPr lang="en-GB" sz="1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395536" y="6093296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elf</a:t>
            </a:r>
            <a:endParaRPr lang="en-GB" sz="1600" b="1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552044"/>
            <a:ext cx="1742218" cy="185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1556792"/>
            <a:ext cx="1704975" cy="178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1556792"/>
            <a:ext cx="1806204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1556792"/>
            <a:ext cx="1771650" cy="179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4221088"/>
            <a:ext cx="1670210" cy="183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4221088"/>
            <a:ext cx="1663861" cy="183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016" y="4221088"/>
            <a:ext cx="1806205" cy="1857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221088"/>
            <a:ext cx="1728192" cy="1774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Rectangle 18"/>
          <p:cNvSpPr/>
          <p:nvPr/>
        </p:nvSpPr>
        <p:spPr>
          <a:xfrm>
            <a:off x="183409" y="151198"/>
            <a:ext cx="864096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 smtClean="0"/>
              <a:t>Figure </a:t>
            </a:r>
            <a:r>
              <a:rPr lang="en-GB" sz="1400" dirty="0"/>
              <a:t>2. Brain activations (top row) and de-activations (bottom row) during various task conditions in the healthy group (height threshold p=0.001; cluster-corrected p &lt; 0.05).  In each panel three glass brain projections are shown viewed from the side, back and top of the brain. Voxels exceeding the activation or deactivation threshold are shown in grey.     </a:t>
            </a:r>
          </a:p>
        </p:txBody>
      </p:sp>
    </p:spTree>
    <p:extLst>
      <p:ext uri="{BB962C8B-B14F-4D97-AF65-F5344CB8AC3E}">
        <p14:creationId xmlns:p14="http://schemas.microsoft.com/office/powerpoint/2010/main" val="1114469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4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nstitute of Psychiatr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para, Adegboyega</dc:creator>
  <cp:lastModifiedBy>Kumari, Veena</cp:lastModifiedBy>
  <cp:revision>5</cp:revision>
  <dcterms:created xsi:type="dcterms:W3CDTF">2014-12-30T11:29:20Z</dcterms:created>
  <dcterms:modified xsi:type="dcterms:W3CDTF">2015-10-13T21:34:23Z</dcterms:modified>
</cp:coreProperties>
</file>